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handoutMasterIdLst>
    <p:handoutMasterId r:id="rId5"/>
  </p:handoutMasterIdLst>
  <p:sldIdLst>
    <p:sldId id="306" r:id="rId2"/>
    <p:sldId id="305" r:id="rId3"/>
  </p:sldIdLst>
  <p:sldSz cx="6858000" cy="9906000" type="A4"/>
  <p:notesSz cx="9866313" cy="6735763"/>
  <p:defaultTextStyle>
    <a:defPPr>
      <a:defRPr lang="ja-JP"/>
    </a:defPPr>
    <a:lvl1pPr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panose="020B0604020202020204" pitchFamily="34" charset="0"/>
        <a:ea typeface="ＭＳ Ｐゴシック" panose="020B0600070205080204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6699"/>
    <a:srgbClr val="99FF99"/>
    <a:srgbClr val="CC99FF"/>
    <a:srgbClr val="00FFFF"/>
    <a:srgbClr val="FF5050"/>
    <a:srgbClr val="0066FF"/>
    <a:srgbClr val="0000FF"/>
    <a:srgbClr val="CCCCFF"/>
    <a:srgbClr val="CCFFCC"/>
    <a:srgbClr val="CC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661" autoAdjust="0"/>
    <p:restoredTop sz="93673" autoAdjust="0"/>
  </p:normalViewPr>
  <p:slideViewPr>
    <p:cSldViewPr snapToGrid="0">
      <p:cViewPr varScale="1">
        <p:scale>
          <a:sx n="34" d="100"/>
          <a:sy n="34" d="100"/>
        </p:scale>
        <p:origin x="1374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="" xmlns:a16="http://schemas.microsoft.com/office/drawing/2014/main" id="{392496C7-CAE4-432D-873A-090DC6D7C397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6937" cy="338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="" xmlns:a16="http://schemas.microsoft.com/office/drawing/2014/main" id="{4C94FC1D-9CA3-4383-A515-A3BA9503FDE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587791" y="0"/>
            <a:ext cx="4276935" cy="338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fld id="{AAB04E5D-EF91-4816-8FFB-8FC51B7B0E8F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="" xmlns:a16="http://schemas.microsoft.com/office/drawing/2014/main" id="{C4610A8B-7830-439F-805E-0A075E0062CC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6397625"/>
            <a:ext cx="4276937" cy="338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="" xmlns:a16="http://schemas.microsoft.com/office/drawing/2014/main" id="{EA482D4D-AB50-45D8-9507-1F29BE3B5AE8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587791" y="6397625"/>
            <a:ext cx="4276935" cy="33813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FCA4984D-2067-422F-9189-ACBE71EB3E2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37445630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275348" cy="338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9376" y="0"/>
            <a:ext cx="4275348" cy="338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1B0955D-1493-4615-8B0B-28D7D25EB410}" type="datetimeFigureOut">
              <a:rPr kumimoji="1" lang="ja-JP" altLang="en-US" smtClean="0"/>
              <a:t>2022/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146550" y="841375"/>
            <a:ext cx="157321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7109" y="3241677"/>
            <a:ext cx="7892097" cy="265271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6397625"/>
            <a:ext cx="4275348" cy="338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9376" y="6397625"/>
            <a:ext cx="4275348" cy="338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8C5448D-AA9F-4242-90EC-F65A6ACC11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81758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EDB45C-B0D1-4DAD-A7C1-5A032F1E6119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C51C77-5075-48FD-B2FC-F975987965C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514014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EB09A0-888C-4736-AF4F-540700EFC86A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04FB8A-4DF8-4CB9-9DF6-E0453C47140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337804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85C597-43CD-453F-A3E1-8E04FCF2C31A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21F377-D11E-474F-8FB0-5432274DD1A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30258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2B8230-C6C5-4754-A9B3-53EC28C71350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2D8F5F-3EC9-43C5-B81D-337550A3521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996665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44CDB1-C893-4AD0-9551-57BB2904D1F7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526E79-88F4-4B2E-8A58-4BB3FF5CB50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643633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E88FBD-2581-4F02-B0F6-E227391FDD7F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65C9F2-BE47-49E7-AE7B-596AED1327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2588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D34CBB-05D6-44A7-8F3E-109DE06B6DD9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A7946E-1D79-41DA-A9C2-F1656E285D0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925134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542413-9D3F-412A-9EE8-F38BA393F6FC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F54F7E-D827-4AC4-AF9D-E20CDCDD454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09835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97818B-3207-471D-BF19-BBE0451D54AF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A90207-D51F-440C-BFAD-C573EBEFBBD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91863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5CFD20-A934-4D2F-A6BB-93A5B844A37D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BFE58D-E80E-4B16-98FC-F7EBD7E5427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7463913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rtlCol="0">
            <a:normAutofit/>
          </a:bodyPr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lvl="0"/>
            <a:r>
              <a:rPr lang="ja-JP" altLang="en-US" noProof="0"/>
              <a:t>図を追加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8ED136D-3D0F-42A8-BB20-3DFAF9951D08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DF94B0-D2F0-444B-8C5D-94B1F650B81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697792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71488" y="527050"/>
            <a:ext cx="5915025" cy="1914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タイトルの書式設定</a:t>
            </a:r>
            <a:endParaRPr lang="en-US" altLang="ja-JP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71488" y="2636838"/>
            <a:ext cx="5915025" cy="62849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altLang="ja-JP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A1752F94-C681-42D4-831D-8EE35BEC9D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2100"/>
            <a:ext cx="154305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A0ACEF99-F228-4817-AFF2-46814C26EEC2}" type="datetimeFigureOut">
              <a:rPr lang="ja-JP" altLang="en-US"/>
              <a:pPr>
                <a:defRPr/>
              </a:pPr>
              <a:t>2022/2/16</a:t>
            </a:fld>
            <a:endParaRPr lang="ja-JP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7E830AB-5373-465D-81DD-A366943AC43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2100"/>
            <a:ext cx="2314575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9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EBAB9FC5-A857-4DE4-8C22-40070A17EE7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2100"/>
            <a:ext cx="154305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9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BC242D30-C40D-4739-8A12-7D750D082620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2pPr>
      <a:lvl3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3pPr>
      <a:lvl4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4pPr>
      <a:lvl5pPr algn="l" defTabSz="685800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5pPr>
      <a:lvl6pPr marL="4572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6pPr>
      <a:lvl7pPr marL="9144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7pPr>
      <a:lvl8pPr marL="13716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8pPr>
      <a:lvl9pPr marL="1828800" algn="l" defTabSz="685800" rtl="0" fontAlgn="base">
        <a:lnSpc>
          <a:spcPct val="90000"/>
        </a:lnSpc>
        <a:spcBef>
          <a:spcPct val="0"/>
        </a:spcBef>
        <a:spcAft>
          <a:spcPct val="0"/>
        </a:spcAft>
        <a:defRPr kumimoji="1" sz="3300">
          <a:solidFill>
            <a:schemeClr val="tx1"/>
          </a:solidFill>
          <a:latin typeface="Calibri Light" panose="020F0302020204030204" pitchFamily="34" charset="0"/>
          <a:ea typeface="ＭＳ Ｐゴシック" panose="020B0600070205080204" pitchFamily="50" charset="-128"/>
        </a:defRPr>
      </a:lvl9pPr>
    </p:titleStyle>
    <p:bodyStyle>
      <a:lvl1pPr marL="171450" indent="-171450" algn="l" defTabSz="685800" rtl="0" eaLnBrk="0" fontAlgn="base" hangingPunct="0">
        <a:lnSpc>
          <a:spcPct val="90000"/>
        </a:lnSpc>
        <a:spcBef>
          <a:spcPts val="750"/>
        </a:spcBef>
        <a:spcAft>
          <a:spcPct val="0"/>
        </a:spcAft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0" fontAlgn="base" hangingPunct="0">
        <a:lnSpc>
          <a:spcPct val="90000"/>
        </a:lnSpc>
        <a:spcBef>
          <a:spcPts val="375"/>
        </a:spcBef>
        <a:spcAft>
          <a:spcPct val="0"/>
        </a:spcAft>
        <a:buFont typeface="Arial" panose="020B0604020202020204" pitchFamily="34" charset="0"/>
        <a:buChar char="•"/>
        <a:defRPr kumimoji="1" sz="13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テキスト ボックス 1">
            <a:extLst>
              <a:ext uri="{FF2B5EF4-FFF2-40B4-BE49-F238E27FC236}">
                <a16:creationId xmlns="" xmlns:a16="http://schemas.microsoft.com/office/drawing/2014/main" id="{F4ED7D3F-A4CC-47CF-9C4D-BAAED46F6D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9990" y="5684632"/>
            <a:ext cx="6561810" cy="64633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just" fontAlgn="auto"/>
            <a:r>
              <a:rPr lang="en-US" altLang="ja-JP" sz="1200" b="1" dirty="0">
                <a:cs typeface="Arial" panose="020B0604020202020204" pitchFamily="34" charset="0"/>
              </a:rPr>
              <a:t>Supplementary Fig. </a:t>
            </a:r>
            <a:r>
              <a:rPr lang="en-US" altLang="ja-JP" sz="1200" b="1" dirty="0" smtClean="0">
                <a:cs typeface="Arial" panose="020B0604020202020204" pitchFamily="34" charset="0"/>
              </a:rPr>
              <a:t>S1</a:t>
            </a:r>
          </a:p>
          <a:p>
            <a:pPr algn="just" fontAlgn="auto"/>
            <a:r>
              <a:rPr lang="en-US" altLang="ja-JP" sz="1200" dirty="0" smtClean="0"/>
              <a:t>Colonies </a:t>
            </a:r>
            <a:r>
              <a:rPr lang="en-US" altLang="ja-JP" sz="1200" dirty="0"/>
              <a:t>of </a:t>
            </a:r>
            <a:r>
              <a:rPr lang="en-US" altLang="ja-JP" sz="1200" i="1" dirty="0"/>
              <a:t>N. commune</a:t>
            </a:r>
            <a:r>
              <a:rPr lang="en-US" altLang="ja-JP" sz="1200" dirty="0"/>
              <a:t>. a, dried colonies (0.1 g) before rewetting. b, those 10 min after addition of rewetting water. c, rewetted ones in a glass vial for acetylene reduction assay</a:t>
            </a:r>
            <a:r>
              <a:rPr lang="en-US" altLang="ja-JP" sz="1200" dirty="0" smtClean="0"/>
              <a:t>.</a:t>
            </a:r>
            <a:endParaRPr lang="ja-JP" altLang="ja-JP" sz="1200" dirty="0"/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198334"/>
            <a:ext cx="6858000" cy="2202176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5330754" y="5046826"/>
            <a:ext cx="6735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HGPｺﾞｼｯｸE" panose="020B0900000000000000" pitchFamily="50" charset="-128"/>
                <a:ea typeface="HGPｺﾞｼｯｸE" panose="020B0900000000000000" pitchFamily="50" charset="-128"/>
              </a:rPr>
              <a:t>3 cm</a:t>
            </a:r>
            <a:endParaRPr kumimoji="1" lang="ja-JP" altLang="en-US" dirty="0">
              <a:latin typeface="HGPｺﾞｼｯｸE" panose="020B0900000000000000" pitchFamily="50" charset="-128"/>
              <a:ea typeface="HGPｺﾞｼｯｸE" panose="020B0900000000000000" pitchFamily="50" charset="-128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985" y="3198572"/>
            <a:ext cx="35618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2400" dirty="0" smtClean="0"/>
              <a:t>a</a:t>
            </a:r>
            <a:endParaRPr kumimoji="1" lang="ja-JP" altLang="en-US" sz="2400" dirty="0"/>
          </a:p>
        </p:txBody>
      </p:sp>
      <p:sp>
        <p:nvSpPr>
          <p:cNvPr id="52" name="テキスト ボックス 51"/>
          <p:cNvSpPr txBox="1"/>
          <p:nvPr/>
        </p:nvSpPr>
        <p:spPr>
          <a:xfrm>
            <a:off x="2745945" y="3214787"/>
            <a:ext cx="356188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dirty="0"/>
              <a:t>b</a:t>
            </a:r>
            <a:endParaRPr kumimoji="1" lang="ja-JP" altLang="en-US" sz="2400" dirty="0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427534" y="3231002"/>
            <a:ext cx="338554" cy="46166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2400" dirty="0" smtClean="0"/>
              <a:t>c</a:t>
            </a:r>
            <a:endParaRPr kumimoji="1" lang="ja-JP" altLang="en-US" sz="2400" dirty="0"/>
          </a:p>
        </p:txBody>
      </p:sp>
    </p:spTree>
    <p:extLst>
      <p:ext uri="{BB962C8B-B14F-4D97-AF65-F5344CB8AC3E}">
        <p14:creationId xmlns:p14="http://schemas.microsoft.com/office/powerpoint/2010/main" val="12776595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テキスト ボックス 1">
            <a:extLst>
              <a:ext uri="{FF2B5EF4-FFF2-40B4-BE49-F238E27FC236}">
                <a16:creationId xmlns="" xmlns:a16="http://schemas.microsoft.com/office/drawing/2014/main" id="{F4ED7D3F-A4CC-47CF-9C4D-BAAED46F6D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599" y="8242548"/>
            <a:ext cx="6180676" cy="8309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just" fontAlgn="auto"/>
            <a:r>
              <a:rPr lang="en-US" altLang="ja-JP" sz="1200" b="1" dirty="0">
                <a:cs typeface="Arial" panose="020B0604020202020204" pitchFamily="34" charset="0"/>
              </a:rPr>
              <a:t>Supplementary Fig. </a:t>
            </a:r>
            <a:r>
              <a:rPr lang="en-US" altLang="ja-JP" sz="1200" b="1" dirty="0" smtClean="0">
                <a:cs typeface="Arial" panose="020B0604020202020204" pitchFamily="34" charset="0"/>
              </a:rPr>
              <a:t>S2</a:t>
            </a:r>
          </a:p>
          <a:p>
            <a:pPr algn="just" fontAlgn="auto"/>
            <a:r>
              <a:rPr lang="en-US" altLang="ja-JP" sz="1200" dirty="0" smtClean="0"/>
              <a:t>Gas-liquid </a:t>
            </a:r>
            <a:r>
              <a:rPr lang="en-US" altLang="ja-JP" sz="1200" dirty="0"/>
              <a:t>chromatogram. Conversion from acetylene (</a:t>
            </a:r>
            <a:r>
              <a:rPr lang="en-US" altLang="ja-JP" sz="1200" dirty="0" smtClean="0"/>
              <a:t>red arrow) </a:t>
            </a:r>
            <a:r>
              <a:rPr lang="en-US" altLang="ja-JP" sz="1200" dirty="0"/>
              <a:t>to ethylene (</a:t>
            </a:r>
            <a:r>
              <a:rPr lang="en-US" altLang="ja-JP" sz="1200" dirty="0" smtClean="0"/>
              <a:t>blue arrow) </a:t>
            </a:r>
            <a:r>
              <a:rPr lang="en-US" altLang="ja-JP" sz="1200" dirty="0"/>
              <a:t>was determined. The first peak just after injection represents a fluctuation by the injected air</a:t>
            </a:r>
            <a:r>
              <a:rPr lang="en-US" altLang="ja-JP" sz="1200" dirty="0" smtClean="0"/>
              <a:t>.</a:t>
            </a:r>
            <a:endParaRPr lang="ja-JP" altLang="ja-JP" sz="1200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200000">
            <a:off x="-321651" y="1893014"/>
            <a:ext cx="8281951" cy="4540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040341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82</TotalTime>
  <Words>87</Words>
  <Application>Microsoft Office PowerPoint</Application>
  <PresentationFormat>A4 210 x 297 mm</PresentationFormat>
  <Paragraphs>8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9" baseType="lpstr">
      <vt:lpstr>HGPｺﾞｼｯｸE</vt:lpstr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dojo</dc:creator>
  <cp:lastModifiedBy>kh</cp:lastModifiedBy>
  <cp:revision>1010</cp:revision>
  <cp:lastPrinted>2021-03-22T05:22:05Z</cp:lastPrinted>
  <dcterms:created xsi:type="dcterms:W3CDTF">2015-07-31T05:56:30Z</dcterms:created>
  <dcterms:modified xsi:type="dcterms:W3CDTF">2022-02-16T01:03:25Z</dcterms:modified>
</cp:coreProperties>
</file>